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4" r:id="rId2"/>
  </p:sldIdLst>
  <p:sldSz cx="6858000" cy="9144000" type="screen4x3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 autoAdjust="0"/>
    <p:restoredTop sz="94676" autoAdjust="0"/>
  </p:normalViewPr>
  <p:slideViewPr>
    <p:cSldViewPr>
      <p:cViewPr>
        <p:scale>
          <a:sx n="100" d="100"/>
          <a:sy n="100" d="100"/>
        </p:scale>
        <p:origin x="-1452" y="6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FE555D-ECA8-4B05-BB7B-46DB13C02D3B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1696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1A6C07-1ED5-48E5-9F9F-17C16A106B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3203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09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527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93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2105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312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256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3678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67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949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384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397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861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52918" y="532407"/>
            <a:ext cx="60486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ry Table 3: Cell wall composition in a mixed population (a) and mapping family (b).  All carbohydrates are in mg g</a:t>
            </a:r>
            <a:r>
              <a:rPr lang="en-GB" sz="1200" baseline="30000" dirty="0" smtClean="0"/>
              <a:t>-1</a:t>
            </a:r>
            <a:r>
              <a:rPr lang="en-GB" sz="1200" dirty="0" smtClean="0"/>
              <a:t> DW</a:t>
            </a:r>
            <a:r>
              <a:rPr lang="en-GB" sz="1200" dirty="0"/>
              <a:t>. Statistics show differences </a:t>
            </a:r>
            <a:r>
              <a:rPr lang="en-GB" sz="1200" dirty="0" smtClean="0"/>
              <a:t>between all  </a:t>
            </a:r>
            <a:r>
              <a:rPr lang="en-GB" sz="1200" dirty="0"/>
              <a:t>genotypes from ANOVA (P= ≤ 0.05). </a:t>
            </a:r>
            <a:r>
              <a:rPr lang="en-GB" sz="1200" dirty="0" smtClean="0"/>
              <a:t>N=3, ± SE.</a:t>
            </a:r>
            <a:endParaRPr lang="en-GB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100890" y="147565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100890" y="479403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7878247"/>
              </p:ext>
            </p:extLst>
          </p:nvPr>
        </p:nvGraphicFramePr>
        <p:xfrm>
          <a:off x="604946" y="1493987"/>
          <a:ext cx="5028407" cy="6034070"/>
        </p:xfrm>
        <a:graphic>
          <a:graphicData uri="http://schemas.openxmlformats.org/drawingml/2006/table">
            <a:tbl>
              <a:tblPr/>
              <a:tblGrid>
                <a:gridCol w="440663"/>
                <a:gridCol w="358505"/>
                <a:gridCol w="89626"/>
                <a:gridCol w="207261"/>
                <a:gridCol w="358505"/>
                <a:gridCol w="89626"/>
                <a:gridCol w="207261"/>
                <a:gridCol w="358505"/>
                <a:gridCol w="89626"/>
                <a:gridCol w="207261"/>
                <a:gridCol w="358505"/>
                <a:gridCol w="89626"/>
                <a:gridCol w="207261"/>
                <a:gridCol w="358505"/>
                <a:gridCol w="89626"/>
                <a:gridCol w="207261"/>
                <a:gridCol w="358505"/>
                <a:gridCol w="89626"/>
                <a:gridCol w="207261"/>
                <a:gridCol w="358505"/>
                <a:gridCol w="89626"/>
                <a:gridCol w="207261"/>
              </a:tblGrid>
              <a:tr h="2234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opulation Genotyp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abin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lact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an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ylan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nn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ul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gnin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9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8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8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7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3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4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2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7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4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3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2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0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6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2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3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6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1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1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4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4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4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6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9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8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1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9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7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3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6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3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4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4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5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Pr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9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1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6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7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5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52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pping Family Genotyp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abin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lact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an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ylan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nn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ulose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gnin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oliath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5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5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7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9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2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7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2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9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0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1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4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6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1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2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9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2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2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8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1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9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3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7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0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2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0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4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9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9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6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8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6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1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9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8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7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0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6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6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7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2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1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1.4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7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9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6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8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.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4.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1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9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7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8.2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2.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0.0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.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587" marR="5587" marT="558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587" marR="5587" marT="558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7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Pr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8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0.00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0.00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66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7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5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0.001</a:t>
                      </a:r>
                    </a:p>
                  </a:txBody>
                  <a:tcPr marL="5587" marR="5587" marT="558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4939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55</TotalTime>
  <Words>1052</Words>
  <Application>Microsoft Office PowerPoint</Application>
  <PresentationFormat>On-screen Show (4:3)</PresentationFormat>
  <Paragraphs>10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berystwyth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p</dc:creator>
  <cp:lastModifiedBy>sap</cp:lastModifiedBy>
  <cp:revision>83</cp:revision>
  <cp:lastPrinted>2015-03-27T09:20:34Z</cp:lastPrinted>
  <dcterms:created xsi:type="dcterms:W3CDTF">2014-04-04T15:40:13Z</dcterms:created>
  <dcterms:modified xsi:type="dcterms:W3CDTF">2015-03-27T13:31:23Z</dcterms:modified>
</cp:coreProperties>
</file>